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037263" cy="80454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3DFC6-EBB3-4102-A7FB-497FDC0DCF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543240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1680" y="4651560"/>
            <a:ext cx="543240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85EC3-F2D6-4B93-8952-874BE82374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08520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1680" y="465156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085200" y="465156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34184-ABBD-4068-A540-160259182F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38400" y="187812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75120" y="187812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1680" y="465156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38400" y="465156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75120" y="4651560"/>
            <a:ext cx="17488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8A79B-1AF5-4C82-9BC5-FE03BB727D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1680" y="1878120"/>
            <a:ext cx="5432400" cy="5310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9AD18-1775-4DC8-AA82-FDAFC65D6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543240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AB6D6-D358-4DEF-A1A6-959CDBD493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265068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085200" y="1878120"/>
            <a:ext cx="265068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20C3E-65EB-4CB1-871A-C1EBC0CB0E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1C1D8-1ED4-4FE0-9DC6-D160B20DF5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1680" y="322200"/>
            <a:ext cx="5432400" cy="6219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AACAE-DEAC-4E79-843D-2BD1A2E385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085200" y="1878120"/>
            <a:ext cx="265068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1680" y="465156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86A0E-DE61-442E-B7CF-2E1966A941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265068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08520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085200" y="465156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983D2-BEDD-481E-892E-34A58E5FCF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168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085200" y="1878120"/>
            <a:ext cx="265068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1680" y="4651560"/>
            <a:ext cx="5432400" cy="253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60132-FD0C-497D-B9C6-6C1B42B533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1680" y="322200"/>
            <a:ext cx="5432400" cy="134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1680" y="1878120"/>
            <a:ext cx="5432400" cy="531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13160" indent="-2743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97280" indent="-2192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36120" indent="-2192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974960" indent="-219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974960" indent="-219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974960" indent="-219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1320" y="7327440"/>
            <a:ext cx="1407960" cy="55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62080" y="7327440"/>
            <a:ext cx="1911600" cy="55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25760" y="7327440"/>
            <a:ext cx="1408320" cy="55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3C3C25-36BD-4BA4-B16E-9DD0235D049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22400" y="138240"/>
            <a:ext cx="3962160" cy="7619760"/>
            <a:chOff x="122400" y="138240"/>
            <a:chExt cx="3962160" cy="7619760"/>
          </a:xfrm>
        </p:grpSpPr>
        <p:sp>
          <p:nvSpPr>
            <p:cNvPr id="42" name=""/>
            <p:cNvSpPr/>
            <p:nvPr/>
          </p:nvSpPr>
          <p:spPr>
            <a:xfrm rot="16200000">
              <a:off x="-1706040" y="1967040"/>
              <a:ext cx="7619760" cy="3962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426960" y="290880"/>
              <a:ext cx="3351960" cy="7390800"/>
              <a:chOff x="426960" y="290880"/>
              <a:chExt cx="3351960" cy="7390800"/>
            </a:xfrm>
          </p:grpSpPr>
          <p:grpSp>
            <p:nvGrpSpPr>
              <p:cNvPr id="44" name=""/>
              <p:cNvGrpSpPr/>
              <p:nvPr/>
            </p:nvGrpSpPr>
            <p:grpSpPr>
              <a:xfrm>
                <a:off x="3093480" y="290880"/>
                <a:ext cx="685440" cy="7390800"/>
                <a:chOff x="3093480" y="290880"/>
                <a:chExt cx="685440" cy="7390800"/>
              </a:xfrm>
            </p:grpSpPr>
            <p:grpSp>
              <p:nvGrpSpPr>
                <p:cNvPr id="45" name=""/>
                <p:cNvGrpSpPr/>
                <p:nvPr/>
              </p:nvGrpSpPr>
              <p:grpSpPr>
                <a:xfrm>
                  <a:off x="3093480" y="290880"/>
                  <a:ext cx="685440" cy="7162200"/>
                  <a:chOff x="3093480" y="290880"/>
                  <a:chExt cx="685440" cy="7162200"/>
                </a:xfrm>
              </p:grpSpPr>
              <p:pic>
                <p:nvPicPr>
                  <p:cNvPr id="46" name="" descr=""/>
                  <p:cNvPicPr/>
                  <p:nvPr/>
                </p:nvPicPr>
                <p:blipFill>
                  <a:blip r:embed="rId1">
                    <a:lum contrast="12000"/>
                  </a:blip>
                  <a:stretch/>
                </p:blipFill>
                <p:spPr>
                  <a:xfrm rot="16200000">
                    <a:off x="-14472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7" name=""/>
                  <p:cNvSpPr/>
                  <p:nvPr/>
                </p:nvSpPr>
                <p:spPr>
                  <a:xfrm rot="16200000">
                    <a:off x="2090880" y="6322320"/>
                    <a:ext cx="2133360" cy="12816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8" name=""/>
                <p:cNvSpPr/>
                <p:nvPr/>
              </p:nvSpPr>
              <p:spPr>
                <a:xfrm rot="10800000">
                  <a:off x="3244320" y="7498800"/>
                  <a:ext cx="322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U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" name=""/>
              <p:cNvGrpSpPr/>
              <p:nvPr/>
            </p:nvGrpSpPr>
            <p:grpSpPr>
              <a:xfrm>
                <a:off x="2712240" y="290880"/>
                <a:ext cx="685440" cy="7390440"/>
                <a:chOff x="2712240" y="290880"/>
                <a:chExt cx="685440" cy="7390440"/>
              </a:xfrm>
            </p:grpSpPr>
            <p:grpSp>
              <p:nvGrpSpPr>
                <p:cNvPr id="50" name=""/>
                <p:cNvGrpSpPr/>
                <p:nvPr/>
              </p:nvGrpSpPr>
              <p:grpSpPr>
                <a:xfrm>
                  <a:off x="2712240" y="290880"/>
                  <a:ext cx="685440" cy="7162200"/>
                  <a:chOff x="2712240" y="290880"/>
                  <a:chExt cx="685440" cy="7162200"/>
                </a:xfrm>
              </p:grpSpPr>
              <p:pic>
                <p:nvPicPr>
                  <p:cNvPr id="51" name="" descr=""/>
                  <p:cNvPicPr/>
                  <p:nvPr/>
                </p:nvPicPr>
                <p:blipFill>
                  <a:blip r:embed="rId2">
                    <a:lum contrast="12000"/>
                  </a:blip>
                  <a:stretch/>
                </p:blipFill>
                <p:spPr>
                  <a:xfrm rot="16200000">
                    <a:off x="-52596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2" name=""/>
                  <p:cNvSpPr/>
                  <p:nvPr/>
                </p:nvSpPr>
                <p:spPr>
                  <a:xfrm rot="16200000">
                    <a:off x="1709640" y="6321960"/>
                    <a:ext cx="2133360" cy="12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3" name=""/>
                <p:cNvSpPr/>
                <p:nvPr/>
              </p:nvSpPr>
              <p:spPr>
                <a:xfrm rot="10800000">
                  <a:off x="2863440" y="7498440"/>
                  <a:ext cx="322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A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" name=""/>
              <p:cNvGrpSpPr/>
              <p:nvPr/>
            </p:nvGrpSpPr>
            <p:grpSpPr>
              <a:xfrm>
                <a:off x="2331360" y="290880"/>
                <a:ext cx="685440" cy="7390800"/>
                <a:chOff x="2331360" y="290880"/>
                <a:chExt cx="685440" cy="7390800"/>
              </a:xfrm>
            </p:grpSpPr>
            <p:grpSp>
              <p:nvGrpSpPr>
                <p:cNvPr id="55" name=""/>
                <p:cNvGrpSpPr/>
                <p:nvPr/>
              </p:nvGrpSpPr>
              <p:grpSpPr>
                <a:xfrm>
                  <a:off x="2331360" y="290880"/>
                  <a:ext cx="685440" cy="7162200"/>
                  <a:chOff x="2331360" y="290880"/>
                  <a:chExt cx="685440" cy="7162200"/>
                </a:xfrm>
              </p:grpSpPr>
              <p:pic>
                <p:nvPicPr>
                  <p:cNvPr id="56" name="" descr=""/>
                  <p:cNvPicPr/>
                  <p:nvPr/>
                </p:nvPicPr>
                <p:blipFill>
                  <a:blip r:embed="rId3">
                    <a:lum contrast="12000"/>
                  </a:blip>
                  <a:stretch/>
                </p:blipFill>
                <p:spPr>
                  <a:xfrm rot="16200000">
                    <a:off x="-90684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7" name=""/>
                  <p:cNvSpPr/>
                  <p:nvPr/>
                </p:nvSpPr>
                <p:spPr>
                  <a:xfrm rot="16200000">
                    <a:off x="1024560" y="6018120"/>
                    <a:ext cx="2741400" cy="12816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8" name=""/>
                <p:cNvSpPr/>
                <p:nvPr/>
              </p:nvSpPr>
              <p:spPr>
                <a:xfrm rot="10800000">
                  <a:off x="2453760" y="7498800"/>
                  <a:ext cx="360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DC</a:t>
                  </a: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9" name=""/>
              <p:cNvGrpSpPr/>
              <p:nvPr/>
            </p:nvGrpSpPr>
            <p:grpSpPr>
              <a:xfrm>
                <a:off x="1950840" y="290880"/>
                <a:ext cx="685440" cy="7390440"/>
                <a:chOff x="1950840" y="290880"/>
                <a:chExt cx="685440" cy="7390440"/>
              </a:xfrm>
            </p:grpSpPr>
            <p:grpSp>
              <p:nvGrpSpPr>
                <p:cNvPr id="60" name=""/>
                <p:cNvGrpSpPr/>
                <p:nvPr/>
              </p:nvGrpSpPr>
              <p:grpSpPr>
                <a:xfrm>
                  <a:off x="1950840" y="290880"/>
                  <a:ext cx="685440" cy="7162200"/>
                  <a:chOff x="1950840" y="290880"/>
                  <a:chExt cx="685440" cy="7162200"/>
                </a:xfrm>
              </p:grpSpPr>
              <p:pic>
                <p:nvPicPr>
                  <p:cNvPr id="61" name="" descr=""/>
                  <p:cNvPicPr/>
                  <p:nvPr/>
                </p:nvPicPr>
                <p:blipFill>
                  <a:blip r:embed="rId4">
                    <a:lum contrast="12000"/>
                  </a:blip>
                  <a:stretch/>
                </p:blipFill>
                <p:spPr>
                  <a:xfrm rot="16200000">
                    <a:off x="-128736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2" name=""/>
                  <p:cNvSpPr/>
                  <p:nvPr/>
                </p:nvSpPr>
                <p:spPr>
                  <a:xfrm rot="16200000">
                    <a:off x="872280" y="6246000"/>
                    <a:ext cx="2285640" cy="12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3" name=""/>
                <p:cNvSpPr/>
                <p:nvPr/>
              </p:nvSpPr>
              <p:spPr>
                <a:xfrm rot="10800000">
                  <a:off x="2146680" y="7498440"/>
                  <a:ext cx="238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uI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4" name=""/>
              <p:cNvGrpSpPr/>
              <p:nvPr/>
            </p:nvGrpSpPr>
            <p:grpSpPr>
              <a:xfrm>
                <a:off x="1569600" y="290880"/>
                <a:ext cx="685440" cy="7390800"/>
                <a:chOff x="1569600" y="290880"/>
                <a:chExt cx="685440" cy="7390800"/>
              </a:xfrm>
            </p:grpSpPr>
            <p:sp>
              <p:nvSpPr>
                <p:cNvPr id="65" name=""/>
                <p:cNvSpPr/>
                <p:nvPr/>
              </p:nvSpPr>
              <p:spPr>
                <a:xfrm rot="10800000">
                  <a:off x="1720080" y="7498800"/>
                  <a:ext cx="305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N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6" name=""/>
                <p:cNvGrpSpPr/>
                <p:nvPr/>
              </p:nvGrpSpPr>
              <p:grpSpPr>
                <a:xfrm>
                  <a:off x="1569600" y="290880"/>
                  <a:ext cx="685440" cy="7238520"/>
                  <a:chOff x="1569600" y="290880"/>
                  <a:chExt cx="685440" cy="7238520"/>
                </a:xfrm>
              </p:grpSpPr>
              <p:pic>
                <p:nvPicPr>
                  <p:cNvPr id="67" name="" descr=""/>
                  <p:cNvPicPr/>
                  <p:nvPr/>
                </p:nvPicPr>
                <p:blipFill>
                  <a:blip r:embed="rId5">
                    <a:lum contrast="12000"/>
                  </a:blip>
                  <a:stretch/>
                </p:blipFill>
                <p:spPr>
                  <a:xfrm rot="16200000">
                    <a:off x="-166860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8" name=""/>
                  <p:cNvSpPr/>
                  <p:nvPr/>
                </p:nvSpPr>
                <p:spPr>
                  <a:xfrm rot="16200000">
                    <a:off x="571320" y="6408000"/>
                    <a:ext cx="2133360" cy="1094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9" name=""/>
              <p:cNvGrpSpPr/>
              <p:nvPr/>
            </p:nvGrpSpPr>
            <p:grpSpPr>
              <a:xfrm>
                <a:off x="426960" y="306720"/>
                <a:ext cx="685440" cy="7374600"/>
                <a:chOff x="426960" y="306720"/>
                <a:chExt cx="685440" cy="7374600"/>
              </a:xfrm>
            </p:grpSpPr>
            <p:grpSp>
              <p:nvGrpSpPr>
                <p:cNvPr id="70" name=""/>
                <p:cNvGrpSpPr/>
                <p:nvPr/>
              </p:nvGrpSpPr>
              <p:grpSpPr>
                <a:xfrm>
                  <a:off x="426960" y="306720"/>
                  <a:ext cx="685440" cy="7162200"/>
                  <a:chOff x="426960" y="306720"/>
                  <a:chExt cx="685440" cy="7162200"/>
                </a:xfrm>
              </p:grpSpPr>
              <p:pic>
                <p:nvPicPr>
                  <p:cNvPr id="71" name="" descr=""/>
                  <p:cNvPicPr/>
                  <p:nvPr/>
                </p:nvPicPr>
                <p:blipFill>
                  <a:blip r:embed="rId6">
                    <a:lum contrast="12000"/>
                  </a:blip>
                  <a:stretch/>
                </p:blipFill>
                <p:spPr>
                  <a:xfrm rot="16200000">
                    <a:off x="-2811240" y="354492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2" name=""/>
                  <p:cNvSpPr/>
                  <p:nvPr/>
                </p:nvSpPr>
                <p:spPr>
                  <a:xfrm rot="16200000">
                    <a:off x="-561600" y="6347520"/>
                    <a:ext cx="2133360" cy="10908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3" name=""/>
                <p:cNvSpPr/>
                <p:nvPr/>
              </p:nvSpPr>
              <p:spPr>
                <a:xfrm rot="10800000">
                  <a:off x="561960" y="7498440"/>
                  <a:ext cx="314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QA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" name=""/>
              <p:cNvGrpSpPr/>
              <p:nvPr/>
            </p:nvGrpSpPr>
            <p:grpSpPr>
              <a:xfrm>
                <a:off x="1188720" y="290880"/>
                <a:ext cx="685440" cy="7390800"/>
                <a:chOff x="1188720" y="290880"/>
                <a:chExt cx="685440" cy="7390800"/>
              </a:xfrm>
            </p:grpSpPr>
            <p:sp>
              <p:nvSpPr>
                <p:cNvPr id="75" name=""/>
                <p:cNvSpPr/>
                <p:nvPr/>
              </p:nvSpPr>
              <p:spPr>
                <a:xfrm rot="10800000">
                  <a:off x="1323000" y="7498800"/>
                  <a:ext cx="323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cI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6" name=""/>
                <p:cNvGrpSpPr/>
                <p:nvPr/>
              </p:nvGrpSpPr>
              <p:grpSpPr>
                <a:xfrm>
                  <a:off x="1188720" y="290880"/>
                  <a:ext cx="685440" cy="7238520"/>
                  <a:chOff x="1188720" y="290880"/>
                  <a:chExt cx="685440" cy="7238520"/>
                </a:xfrm>
              </p:grpSpPr>
              <p:pic>
                <p:nvPicPr>
                  <p:cNvPr id="77" name="" descr=""/>
                  <p:cNvPicPr/>
                  <p:nvPr/>
                </p:nvPicPr>
                <p:blipFill>
                  <a:blip r:embed="rId7">
                    <a:lum contrast="12000"/>
                  </a:blip>
                  <a:stretch/>
                </p:blipFill>
                <p:spPr>
                  <a:xfrm rot="16200000">
                    <a:off x="-204948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8" name=""/>
                  <p:cNvSpPr/>
                  <p:nvPr/>
                </p:nvSpPr>
                <p:spPr>
                  <a:xfrm rot="16200000">
                    <a:off x="199800" y="6408000"/>
                    <a:ext cx="2133360" cy="10908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79" name=""/>
              <p:cNvGrpSpPr/>
              <p:nvPr/>
            </p:nvGrpSpPr>
            <p:grpSpPr>
              <a:xfrm>
                <a:off x="807840" y="290880"/>
                <a:ext cx="685440" cy="7390800"/>
                <a:chOff x="807840" y="290880"/>
                <a:chExt cx="685440" cy="7390800"/>
              </a:xfrm>
            </p:grpSpPr>
            <p:sp>
              <p:nvSpPr>
                <p:cNvPr id="80" name=""/>
                <p:cNvSpPr/>
                <p:nvPr/>
              </p:nvSpPr>
              <p:spPr>
                <a:xfrm rot="10800000">
                  <a:off x="943200" y="7498800"/>
                  <a:ext cx="3297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AC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1" name=""/>
                <p:cNvGrpSpPr/>
                <p:nvPr/>
              </p:nvGrpSpPr>
              <p:grpSpPr>
                <a:xfrm>
                  <a:off x="807840" y="290880"/>
                  <a:ext cx="685440" cy="7162200"/>
                  <a:chOff x="807840" y="290880"/>
                  <a:chExt cx="685440" cy="7162200"/>
                </a:xfrm>
              </p:grpSpPr>
              <p:pic>
                <p:nvPicPr>
                  <p:cNvPr id="82" name="" descr=""/>
                  <p:cNvPicPr/>
                  <p:nvPr/>
                </p:nvPicPr>
                <p:blipFill>
                  <a:blip r:embed="rId8">
                    <a:lum contrast="12000"/>
                  </a:blip>
                  <a:stretch/>
                </p:blipFill>
                <p:spPr>
                  <a:xfrm rot="16200000">
                    <a:off x="-2430360" y="3529080"/>
                    <a:ext cx="7162200" cy="68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83" name=""/>
                  <p:cNvSpPr/>
                  <p:nvPr/>
                </p:nvSpPr>
                <p:spPr>
                  <a:xfrm rot="16200000">
                    <a:off x="-196560" y="6331680"/>
                    <a:ext cx="2133360" cy="10908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84" name=""/>
            <p:cNvGrpSpPr/>
            <p:nvPr/>
          </p:nvGrpSpPr>
          <p:grpSpPr>
            <a:xfrm>
              <a:off x="350280" y="3263040"/>
              <a:ext cx="152280" cy="532800"/>
              <a:chOff x="350280" y="3263040"/>
              <a:chExt cx="152280" cy="532800"/>
            </a:xfrm>
          </p:grpSpPr>
          <p:sp>
            <p:nvSpPr>
              <p:cNvPr id="85" name=""/>
              <p:cNvSpPr/>
              <p:nvPr/>
            </p:nvSpPr>
            <p:spPr>
              <a:xfrm flipH="1">
                <a:off x="350280" y="326304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350640" y="3263040"/>
                <a:ext cx="0" cy="532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H="1">
                <a:off x="350280" y="379584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"/>
            <p:cNvSpPr/>
            <p:nvPr/>
          </p:nvSpPr>
          <p:spPr>
            <a:xfrm rot="16200000">
              <a:off x="84240" y="3453120"/>
              <a:ext cx="68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pZ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"/>
            <p:cNvGrpSpPr/>
            <p:nvPr/>
          </p:nvGrpSpPr>
          <p:grpSpPr>
            <a:xfrm>
              <a:off x="3719520" y="4818240"/>
              <a:ext cx="228240" cy="1644480"/>
              <a:chOff x="3719520" y="4818240"/>
              <a:chExt cx="228240" cy="1644480"/>
            </a:xfrm>
          </p:grpSpPr>
          <p:sp>
            <p:nvSpPr>
              <p:cNvPr id="90" name=""/>
              <p:cNvSpPr/>
              <p:nvPr/>
            </p:nvSpPr>
            <p:spPr>
              <a:xfrm>
                <a:off x="3719520" y="646272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flipV="1">
                <a:off x="3947760" y="4818240"/>
                <a:ext cx="0" cy="164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3719520" y="481824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3" name=""/>
            <p:cNvGrpSpPr/>
            <p:nvPr/>
          </p:nvGrpSpPr>
          <p:grpSpPr>
            <a:xfrm>
              <a:off x="3703680" y="3796200"/>
              <a:ext cx="228240" cy="950760"/>
              <a:chOff x="3703680" y="3796200"/>
              <a:chExt cx="228240" cy="950760"/>
            </a:xfrm>
          </p:grpSpPr>
          <p:sp>
            <p:nvSpPr>
              <p:cNvPr id="94" name=""/>
              <p:cNvSpPr/>
              <p:nvPr/>
            </p:nvSpPr>
            <p:spPr>
              <a:xfrm>
                <a:off x="3703680" y="474696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flipV="1">
                <a:off x="3931920" y="3796200"/>
                <a:ext cx="0" cy="950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703680" y="379620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3719520" y="6462720"/>
              <a:ext cx="228240" cy="761760"/>
              <a:chOff x="3719520" y="6462720"/>
              <a:chExt cx="228240" cy="761760"/>
            </a:xfrm>
          </p:grpSpPr>
          <p:sp>
            <p:nvSpPr>
              <p:cNvPr id="98" name=""/>
              <p:cNvSpPr/>
              <p:nvPr/>
            </p:nvSpPr>
            <p:spPr>
              <a:xfrm>
                <a:off x="3719520" y="722448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flipV="1">
                <a:off x="3947760" y="6463080"/>
                <a:ext cx="0" cy="76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719520" y="646272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" name=""/>
            <p:cNvSpPr/>
            <p:nvPr/>
          </p:nvSpPr>
          <p:spPr>
            <a:xfrm rot="16200000">
              <a:off x="3486240" y="6680160"/>
              <a:ext cx="5871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hoURB/ pp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6200000">
              <a:off x="3094200" y="5472000"/>
              <a:ext cx="13712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urface sugar-phosphate  modif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6200000">
              <a:off x="3371040" y="4128480"/>
              <a:ext cx="8172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x- hemACD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4" name=""/>
            <p:cNvGrpSpPr/>
            <p:nvPr/>
          </p:nvGrpSpPr>
          <p:grpSpPr>
            <a:xfrm>
              <a:off x="3719520" y="2375640"/>
              <a:ext cx="228240" cy="1267920"/>
              <a:chOff x="3719520" y="2375640"/>
              <a:chExt cx="228240" cy="1267920"/>
            </a:xfrm>
          </p:grpSpPr>
          <p:sp>
            <p:nvSpPr>
              <p:cNvPr id="105" name=""/>
              <p:cNvSpPr/>
              <p:nvPr/>
            </p:nvSpPr>
            <p:spPr>
              <a:xfrm>
                <a:off x="3719520" y="364356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3947760" y="2375640"/>
                <a:ext cx="0" cy="126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719520" y="237564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" name=""/>
            <p:cNvSpPr/>
            <p:nvPr/>
          </p:nvSpPr>
          <p:spPr>
            <a:xfrm rot="16200000">
              <a:off x="3090960" y="2881440"/>
              <a:ext cx="13773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hemL- cytC  biosynthe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" name=""/>
            <p:cNvGrpSpPr/>
            <p:nvPr/>
          </p:nvGrpSpPr>
          <p:grpSpPr>
            <a:xfrm>
              <a:off x="3719520" y="1308600"/>
              <a:ext cx="228240" cy="990360"/>
              <a:chOff x="3719520" y="1308600"/>
              <a:chExt cx="228240" cy="990360"/>
            </a:xfrm>
          </p:grpSpPr>
          <p:sp>
            <p:nvSpPr>
              <p:cNvPr id="110" name=""/>
              <p:cNvSpPr/>
              <p:nvPr/>
            </p:nvSpPr>
            <p:spPr>
              <a:xfrm>
                <a:off x="3719520" y="229896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V="1">
                <a:off x="3947760" y="1308600"/>
                <a:ext cx="0" cy="99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719520" y="1308600"/>
                <a:ext cx="2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" name=""/>
            <p:cNvSpPr/>
            <p:nvPr/>
          </p:nvSpPr>
          <p:spPr>
            <a:xfrm rot="16200000">
              <a:off x="3592440" y="1727280"/>
              <a:ext cx="52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Q/Vit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31T01:16:16Z</dcterms:created>
  <dc:creator>Thoth</dc:creator>
  <dc:description/>
  <dc:language>en-US</dc:language>
  <cp:lastModifiedBy>Thoth</cp:lastModifiedBy>
  <dcterms:modified xsi:type="dcterms:W3CDTF">2014-05-31T01:33:52Z</dcterms:modified>
  <cp:revision>1</cp:revision>
  <dc:subject/>
  <dc:title>Slide 1</dc:title>
</cp:coreProperties>
</file>